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6858000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68"/>
  </p:normalViewPr>
  <p:slideViewPr>
    <p:cSldViewPr snapToGrid="0">
      <p:cViewPr varScale="1">
        <p:scale>
          <a:sx n="94" d="100"/>
          <a:sy n="94" d="100"/>
        </p:scale>
        <p:origin x="307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14125"/>
            <a:ext cx="5829300" cy="300826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538401"/>
            <a:ext cx="5143500" cy="208618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2934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1513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60041"/>
            <a:ext cx="1478756" cy="732264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60041"/>
            <a:ext cx="4350544" cy="732264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4528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7231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154193"/>
            <a:ext cx="5915025" cy="359431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782513"/>
            <a:ext cx="5915025" cy="189016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88462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00203"/>
            <a:ext cx="2914650" cy="54824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00203"/>
            <a:ext cx="2914650" cy="548248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6605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60043"/>
            <a:ext cx="5915025" cy="167014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118188"/>
            <a:ext cx="2901255" cy="103809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156278"/>
            <a:ext cx="2901255" cy="46424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118188"/>
            <a:ext cx="2915543" cy="103809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156278"/>
            <a:ext cx="2915543" cy="46424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8824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9405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7384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6051"/>
            <a:ext cx="2211884" cy="201617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44112"/>
            <a:ext cx="3471863" cy="614054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592229"/>
            <a:ext cx="2211884" cy="480242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2709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76051"/>
            <a:ext cx="2211884" cy="201617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44112"/>
            <a:ext cx="3471863" cy="614054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592229"/>
            <a:ext cx="2211884" cy="4802425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1970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60043"/>
            <a:ext cx="5915025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00203"/>
            <a:ext cx="5915025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008709"/>
            <a:ext cx="154305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5DACAD-8050-47AE-977E-8253486B6832}" type="datetimeFigureOut">
              <a:rPr kumimoji="1" lang="ja-JP" altLang="en-US" smtClean="0"/>
              <a:t>2025/7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008709"/>
            <a:ext cx="2314575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008709"/>
            <a:ext cx="154305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CF111E-08C3-44F4-85ED-F1D47DB40F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10834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AA814D1-948C-B7CE-7F23-3BD7C1636157}"/>
              </a:ext>
            </a:extLst>
          </p:cNvPr>
          <p:cNvSpPr txBox="1"/>
          <p:nvPr/>
        </p:nvSpPr>
        <p:spPr>
          <a:xfrm>
            <a:off x="716702" y="5820000"/>
            <a:ext cx="5463822" cy="21811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Supplementary Figure S2</a:t>
            </a:r>
            <a:endParaRPr lang="ja-JP" altLang="ja-JP" sz="1400" b="1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Distribution of Glasgow Coma Scale scores for phenotypes 2 and 3.</a:t>
            </a:r>
          </a:p>
          <a:p>
            <a:pPr algn="l">
              <a:lnSpc>
                <a:spcPct val="200000"/>
              </a:lnSpc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 boxplot illustrating the distribution of Glasgow Coma Scale scores for phenotypes 2 and 3 was shown. The mean Glasgow Coma Scale score was lower for phenotype 3 than for phenotype 2.</a:t>
            </a:r>
          </a:p>
        </p:txBody>
      </p:sp>
      <p:pic>
        <p:nvPicPr>
          <p:cNvPr id="11" name="図 10">
            <a:extLst>
              <a:ext uri="{FF2B5EF4-FFF2-40B4-BE49-F238E27FC236}">
                <a16:creationId xmlns:a16="http://schemas.microsoft.com/office/drawing/2014/main" id="{C7F5480E-A327-B722-CBF4-EA394543A0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702" y="321536"/>
            <a:ext cx="5424596" cy="5157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6208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3</TotalTime>
  <Words>49</Words>
  <Application>Microsoft Macintosh PowerPoint</Application>
  <PresentationFormat>ユーザー設定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ji yokobori</dc:creator>
  <cp:lastModifiedBy>Takiguchi Toru</cp:lastModifiedBy>
  <cp:revision>8</cp:revision>
  <dcterms:created xsi:type="dcterms:W3CDTF">2025-01-29T22:59:33Z</dcterms:created>
  <dcterms:modified xsi:type="dcterms:W3CDTF">2025-07-01T06:48:01Z</dcterms:modified>
</cp:coreProperties>
</file>